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033" autoAdjust="0"/>
  </p:normalViewPr>
  <p:slideViewPr>
    <p:cSldViewPr>
      <p:cViewPr>
        <p:scale>
          <a:sx n="100" d="100"/>
          <a:sy n="100" d="100"/>
        </p:scale>
        <p:origin x="2670" y="-13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19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5337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835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049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0655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6777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6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0241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3798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1730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7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585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7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2783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6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388923-33DC-49B6-9D7E-5B89603923DE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B6E756-1D37-4281-88EA-EC9FE9224D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4485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56368B60-4E7C-F9CC-DE66-08547FFF3D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8157" y="515620"/>
            <a:ext cx="1213485" cy="431800"/>
          </a:xfrm>
          <a:prstGeom prst="rect">
            <a:avLst/>
          </a:prstGeom>
        </p:spPr>
      </p:pic>
      <p:pic>
        <p:nvPicPr>
          <p:cNvPr id="5" name="Picture 1">
            <a:extLst>
              <a:ext uri="{FF2B5EF4-FFF2-40B4-BE49-F238E27FC236}">
                <a16:creationId xmlns:a16="http://schemas.microsoft.com/office/drawing/2014/main" id="{C46F15D8-DE55-E9E4-4296-BB72E40E32EF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5620385" y="515620"/>
            <a:ext cx="539750" cy="359410"/>
          </a:xfrm>
          <a:prstGeom prst="rect">
            <a:avLst/>
          </a:prstGeom>
        </p:spPr>
      </p:pic>
      <p:sp>
        <p:nvSpPr>
          <p:cNvPr id="9" name="CaixaDeTexto 8">
            <a:extLst>
              <a:ext uri="{FF2B5EF4-FFF2-40B4-BE49-F238E27FC236}">
                <a16:creationId xmlns:a16="http://schemas.microsoft.com/office/drawing/2014/main" id="{0EAC6A57-55F6-0068-7099-0E2B0061645B}"/>
              </a:ext>
            </a:extLst>
          </p:cNvPr>
          <p:cNvSpPr txBox="1"/>
          <p:nvPr/>
        </p:nvSpPr>
        <p:spPr>
          <a:xfrm>
            <a:off x="498156" y="1334037"/>
            <a:ext cx="5994083" cy="1958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1200"/>
              </a:spcBef>
            </a:pPr>
            <a:r>
              <a:rPr 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data</a:t>
            </a:r>
          </a:p>
          <a:p>
            <a:pPr>
              <a:lnSpc>
                <a:spcPct val="150000"/>
              </a:lnSpc>
              <a:spcBef>
                <a:spcPts val="1200"/>
              </a:spcBef>
            </a:pPr>
            <a:endParaRPr lang="pt-PT" sz="1000" i="1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rnessing postbiotics to boost chemotherapy: N-acetylcysteine and tetrahydro β-carboline carboxylic acid as potentiators in pancreatic and colorectal cancer</a:t>
            </a:r>
            <a:endParaRPr lang="pt-PT" sz="10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78D483F8-95CA-E8B2-63D2-F8A58121FE7C}"/>
              </a:ext>
            </a:extLst>
          </p:cNvPr>
          <p:cNvSpPr txBox="1"/>
          <p:nvPr/>
        </p:nvSpPr>
        <p:spPr>
          <a:xfrm>
            <a:off x="498156" y="3411814"/>
            <a:ext cx="5994082" cy="4182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  <a:spcAft>
                <a:spcPts val="1800"/>
              </a:spcAft>
            </a:pP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nessa Rodriguez </a:t>
            </a:r>
            <a:r>
              <a:rPr lang="it-IT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3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nacandida Villani </a:t>
            </a:r>
            <a:r>
              <a:rPr lang="it-IT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argarida Sénica</a:t>
            </a:r>
            <a:r>
              <a:rPr lang="it-IT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3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oncetta Panebianco </a:t>
            </a:r>
            <a:r>
              <a:rPr lang="it-IT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Valerio Pazienza </a:t>
            </a:r>
            <a:r>
              <a:rPr lang="it-IT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, and Ana Preto </a:t>
            </a:r>
            <a:r>
              <a:rPr lang="it-IT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3,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pt-PT" sz="10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9891CAD5-340B-882F-DD14-B55FA00459F3}"/>
              </a:ext>
            </a:extLst>
          </p:cNvPr>
          <p:cNvSpPr txBox="1"/>
          <p:nvPr/>
        </p:nvSpPr>
        <p:spPr>
          <a:xfrm>
            <a:off x="498156" y="4113184"/>
            <a:ext cx="5994082" cy="11143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81810" indent="-125730">
              <a:lnSpc>
                <a:spcPts val="1000"/>
              </a:lnSpc>
            </a:pPr>
            <a:r>
              <a:rPr lang="it-IT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it-IT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Division of Gastroenterology, Fondazione IRCCS Casa Sollievo della Sofferenza, San Giovanni Rotondo, Italy</a:t>
            </a:r>
            <a:endParaRPr lang="pt-PT" sz="8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81810" indent="-125730">
              <a:lnSpc>
                <a:spcPts val="1000"/>
              </a:lnSpc>
            </a:pPr>
            <a:r>
              <a:rPr 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Centre of Molecular and Environmental Biology (CBMA), Department of Biology, University of Minho, 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Campus of </a:t>
            </a:r>
            <a:r>
              <a:rPr 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Gualtar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4710-057 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aga, Portugal</a:t>
            </a:r>
            <a:endParaRPr lang="pt-PT" sz="8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81810" indent="-125730">
              <a:lnSpc>
                <a:spcPts val="1000"/>
              </a:lnSpc>
            </a:pPr>
            <a:r>
              <a:rPr 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IBS-Institute of Science and Innovation for Bio-Sustainability, University of Minho, Campus 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of </a:t>
            </a:r>
            <a:r>
              <a:rPr 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Gualtar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4710-057 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aga, Portugal</a:t>
            </a:r>
            <a:endParaRPr lang="pt-PT" sz="8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81810" indent="-125730">
              <a:lnSpc>
                <a:spcPts val="1000"/>
              </a:lnSpc>
            </a:pPr>
            <a:r>
              <a:rPr lang="en-US" sz="8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800" dirty="0"/>
              <a:t> Correspondence: pazienza_valerio@yahoo.it (V.P.); apreto@bio.uminho.pt (A.P.); Tel.: +351-253-601524 (A.P.)</a:t>
            </a:r>
            <a:endParaRPr lang="pt-PT" sz="800" dirty="0"/>
          </a:p>
        </p:txBody>
      </p:sp>
    </p:spTree>
    <p:extLst>
      <p:ext uri="{BB962C8B-B14F-4D97-AF65-F5344CB8AC3E}">
        <p14:creationId xmlns:p14="http://schemas.microsoft.com/office/powerpoint/2010/main" val="22318975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m 2" descr="Uma imagem com texto, circuito, captura de ecrã, eletrónica&#10;&#10;Os conteúdos gerados por IA podem estar incorretos.">
            <a:extLst>
              <a:ext uri="{FF2B5EF4-FFF2-40B4-BE49-F238E27FC236}">
                <a16:creationId xmlns:a16="http://schemas.microsoft.com/office/drawing/2014/main" id="{C48A773F-F8C7-DEDA-E5DC-CBCF7D9B79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55" y="952565"/>
            <a:ext cx="6473890" cy="3910813"/>
          </a:xfrm>
          <a:prstGeom prst="rect">
            <a:avLst/>
          </a:prstGeom>
        </p:spPr>
      </p:pic>
      <p:pic>
        <p:nvPicPr>
          <p:cNvPr id="4" name="Imagem 3" descr="Uma imagem com texto, captura de ecrã, diagrama, monocromático&#10;&#10;Os conteúdos gerados por IA podem estar incorretos.">
            <a:extLst>
              <a:ext uri="{FF2B5EF4-FFF2-40B4-BE49-F238E27FC236}">
                <a16:creationId xmlns:a16="http://schemas.microsoft.com/office/drawing/2014/main" id="{1B5CBB19-6B3C-7B86-5D3E-436B753C88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55" y="5842781"/>
            <a:ext cx="6473890" cy="3966445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F10DF54C-6EA0-FF73-03A0-5560FECCEC12}"/>
              </a:ext>
            </a:extLst>
          </p:cNvPr>
          <p:cNvSpPr txBox="1"/>
          <p:nvPr/>
        </p:nvSpPr>
        <p:spPr>
          <a:xfrm>
            <a:off x="153953" y="699057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000" dirty="0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4DD8F495-E91F-7247-0319-9CEEDFCC1B64}"/>
              </a:ext>
            </a:extLst>
          </p:cNvPr>
          <p:cNvSpPr txBox="1"/>
          <p:nvPr/>
        </p:nvSpPr>
        <p:spPr>
          <a:xfrm>
            <a:off x="153954" y="5535600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000" dirty="0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F99AB3F4-E872-DCAB-94D9-2C02B6772231}"/>
              </a:ext>
            </a:extLst>
          </p:cNvPr>
          <p:cNvSpPr txBox="1"/>
          <p:nvPr/>
        </p:nvSpPr>
        <p:spPr>
          <a:xfrm>
            <a:off x="153952" y="10016158"/>
            <a:ext cx="6473889" cy="762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flow cytometry dot plots of apoptosis analysis by Annexin V/PI showing the effects of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-acetylcysteine (NAC) in pancreatic cancer cell lines (BxPC-3 and Panc-1) (a) and colorectal cancer cell lines (SW480 and RKO) (b).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879544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4CEFDC-6B4F-0136-9C3B-265BD0B3E1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48AC6698-F553-EC82-35A8-30F72418E7C0}"/>
              </a:ext>
            </a:extLst>
          </p:cNvPr>
          <p:cNvSpPr txBox="1"/>
          <p:nvPr/>
        </p:nvSpPr>
        <p:spPr>
          <a:xfrm>
            <a:off x="153953" y="699057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000" dirty="0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AD59C9F7-C7EE-0944-1C2F-7BDC32C58AA6}"/>
              </a:ext>
            </a:extLst>
          </p:cNvPr>
          <p:cNvSpPr txBox="1"/>
          <p:nvPr/>
        </p:nvSpPr>
        <p:spPr>
          <a:xfrm>
            <a:off x="153954" y="5535600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000" dirty="0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1F3A08BD-267F-EEC7-09AB-7E84AF4AACD1}"/>
              </a:ext>
            </a:extLst>
          </p:cNvPr>
          <p:cNvSpPr txBox="1"/>
          <p:nvPr/>
        </p:nvSpPr>
        <p:spPr>
          <a:xfrm>
            <a:off x="153952" y="10016158"/>
            <a:ext cx="6473889" cy="762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flow cytometry dot plots of apoptosis analysis by Annexin V/PI showing the effects of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trahydro β-carboline carboxylic acid (THC) in pancreatic cancer cell lines (BxPC-3 and Panc-1) (a) and colorectal cancer cell lines (SW480 and RKO) (b).</a:t>
            </a:r>
            <a:endParaRPr lang="en-GB" sz="1000" dirty="0"/>
          </a:p>
        </p:txBody>
      </p:sp>
      <p:pic>
        <p:nvPicPr>
          <p:cNvPr id="5" name="Imagem 4" descr="Uma imagem com texto, captura de ecrã, diagrama, monocromático&#10;&#10;Os conteúdos gerados por IA podem estar incorretos.">
            <a:extLst>
              <a:ext uri="{FF2B5EF4-FFF2-40B4-BE49-F238E27FC236}">
                <a16:creationId xmlns:a16="http://schemas.microsoft.com/office/drawing/2014/main" id="{1713AC16-936C-A17F-73FC-D1A0E0E9B1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159" y="1078773"/>
            <a:ext cx="6343376" cy="3836961"/>
          </a:xfrm>
          <a:prstGeom prst="rect">
            <a:avLst/>
          </a:prstGeom>
        </p:spPr>
      </p:pic>
      <p:pic>
        <p:nvPicPr>
          <p:cNvPr id="9" name="Imagem 8" descr="Uma imagem com texto, captura de ecrã, diagrama&#10;&#10;Os conteúdos gerados por IA podem estar incorretos.">
            <a:extLst>
              <a:ext uri="{FF2B5EF4-FFF2-40B4-BE49-F238E27FC236}">
                <a16:creationId xmlns:a16="http://schemas.microsoft.com/office/drawing/2014/main" id="{052ED22F-0EAE-4ED7-B212-EBD1EAB8F7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161" y="5955750"/>
            <a:ext cx="6343375" cy="3886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2752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5AD89C-BB3C-4B1F-5233-BAACAC7C63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0FEAC443-5A53-EF56-79D1-C8479B6AF85E}"/>
              </a:ext>
            </a:extLst>
          </p:cNvPr>
          <p:cNvSpPr txBox="1"/>
          <p:nvPr/>
        </p:nvSpPr>
        <p:spPr>
          <a:xfrm>
            <a:off x="153953" y="699057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000" dirty="0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F09FFB76-4162-FC2B-FCA8-67739C0ABD69}"/>
              </a:ext>
            </a:extLst>
          </p:cNvPr>
          <p:cNvSpPr txBox="1"/>
          <p:nvPr/>
        </p:nvSpPr>
        <p:spPr>
          <a:xfrm>
            <a:off x="153954" y="5535600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000" dirty="0"/>
          </a:p>
        </p:txBody>
      </p:sp>
      <p:pic>
        <p:nvPicPr>
          <p:cNvPr id="10" name="Imagem 9">
            <a:extLst>
              <a:ext uri="{FF2B5EF4-FFF2-40B4-BE49-F238E27FC236}">
                <a16:creationId xmlns:a16="http://schemas.microsoft.com/office/drawing/2014/main" id="{53B69518-910B-B8E0-ABF7-9581832A73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787" y="1128158"/>
            <a:ext cx="6514426" cy="3443842"/>
          </a:xfrm>
          <a:prstGeom prst="rect">
            <a:avLst/>
          </a:prstGeom>
        </p:spPr>
      </p:pic>
      <p:pic>
        <p:nvPicPr>
          <p:cNvPr id="11" name="Imagem 10">
            <a:extLst>
              <a:ext uri="{FF2B5EF4-FFF2-40B4-BE49-F238E27FC236}">
                <a16:creationId xmlns:a16="http://schemas.microsoft.com/office/drawing/2014/main" id="{AB14F6E8-AE3E-0DD8-51CE-3CF125DD9C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789" y="5951599"/>
            <a:ext cx="6453285" cy="3446403"/>
          </a:xfrm>
          <a:prstGeom prst="rect">
            <a:avLst/>
          </a:prstGeom>
        </p:spPr>
      </p:pic>
      <p:sp>
        <p:nvSpPr>
          <p:cNvPr id="15" name="CaixaDeTexto 14">
            <a:extLst>
              <a:ext uri="{FF2B5EF4-FFF2-40B4-BE49-F238E27FC236}">
                <a16:creationId xmlns:a16="http://schemas.microsoft.com/office/drawing/2014/main" id="{A9D6B749-8ED4-3FAF-8FFC-D3D1C77484DD}"/>
              </a:ext>
            </a:extLst>
          </p:cNvPr>
          <p:cNvSpPr txBox="1"/>
          <p:nvPr/>
        </p:nvSpPr>
        <p:spPr>
          <a:xfrm>
            <a:off x="153951" y="9760144"/>
            <a:ext cx="6453285" cy="762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  <a:defRPr/>
            </a:pPr>
            <a:r>
              <a:rPr lang="it-IT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histograms of cell cycle phase distributions after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-acetylcysteine (NAC) exposure in pancreatic cancer cell lines (BxPC-3 and Panc-1) (a) and colorectal cancer cell lines (SW480 and RKO) (b), assessed by PI staining.</a:t>
            </a:r>
            <a:endParaRPr lang="en-GB" sz="1000" dirty="0">
              <a:solidFill>
                <a:prstClr val="black"/>
              </a:solidFill>
              <a:latin typeface="Aptos" panose="02110004020202020204"/>
            </a:endParaRPr>
          </a:p>
        </p:txBody>
      </p:sp>
    </p:spTree>
    <p:extLst>
      <p:ext uri="{BB962C8B-B14F-4D97-AF65-F5344CB8AC3E}">
        <p14:creationId xmlns:p14="http://schemas.microsoft.com/office/powerpoint/2010/main" val="18808327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1E9BEA-3B61-AAE8-CC97-A4B14A501F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2356A6AE-E4FA-078C-C267-ABD22BF7E033}"/>
              </a:ext>
            </a:extLst>
          </p:cNvPr>
          <p:cNvSpPr txBox="1"/>
          <p:nvPr/>
        </p:nvSpPr>
        <p:spPr>
          <a:xfrm>
            <a:off x="153953" y="699057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000" dirty="0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A7B059B4-832C-A388-3396-82A6A61CC598}"/>
              </a:ext>
            </a:extLst>
          </p:cNvPr>
          <p:cNvSpPr txBox="1"/>
          <p:nvPr/>
        </p:nvSpPr>
        <p:spPr>
          <a:xfrm>
            <a:off x="153954" y="5535600"/>
            <a:ext cx="64738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000" dirty="0"/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3BA86B37-746E-B395-115A-73D4E2F6FD16}"/>
              </a:ext>
            </a:extLst>
          </p:cNvPr>
          <p:cNvSpPr txBox="1"/>
          <p:nvPr/>
        </p:nvSpPr>
        <p:spPr>
          <a:xfrm>
            <a:off x="153951" y="9760144"/>
            <a:ext cx="6453285" cy="762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  <a:defRPr/>
            </a:pPr>
            <a:r>
              <a:rPr lang="it-IT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it-IT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histograms of cell cycle phase distributions after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etrahydro β-carboline carboxylic acid (THC) exposure in pancreatic cancer cell lines (BxPC-3 and Panc-1) (a) and colorectal cancer cell lines (SW480 and RKO) (b), assessed by PI staining.</a:t>
            </a:r>
            <a:endParaRPr lang="en-GB" sz="1000" dirty="0">
              <a:solidFill>
                <a:prstClr val="black"/>
              </a:solidFill>
              <a:latin typeface="Aptos" panose="02110004020202020204"/>
            </a:endParaRPr>
          </a:p>
        </p:txBody>
      </p:sp>
      <p:pic>
        <p:nvPicPr>
          <p:cNvPr id="2" name="Imagem 1">
            <a:extLst>
              <a:ext uri="{FF2B5EF4-FFF2-40B4-BE49-F238E27FC236}">
                <a16:creationId xmlns:a16="http://schemas.microsoft.com/office/drawing/2014/main" id="{5338A82D-58A7-7A24-8845-EB0F96F63C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951" y="1189606"/>
            <a:ext cx="6517844" cy="3473834"/>
          </a:xfrm>
          <a:prstGeom prst="rect">
            <a:avLst/>
          </a:prstGeom>
        </p:spPr>
      </p:pic>
      <p:pic>
        <p:nvPicPr>
          <p:cNvPr id="3" name="Imagem 2">
            <a:extLst>
              <a:ext uri="{FF2B5EF4-FFF2-40B4-BE49-F238E27FC236}">
                <a16:creationId xmlns:a16="http://schemas.microsoft.com/office/drawing/2014/main" id="{E40C0021-023B-B2DD-FAAA-E04DDD1748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953" y="5869262"/>
            <a:ext cx="6504649" cy="3473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98143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</TotalTime>
  <Words>374</Words>
  <Application>Microsoft Office PowerPoint</Application>
  <PresentationFormat>Widescreen</PresentationFormat>
  <Paragraphs>2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Palatino Linotype</vt:lpstr>
      <vt:lpstr>Tema do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garida Rodrigues Sénica</dc:creator>
  <cp:lastModifiedBy>MDPI</cp:lastModifiedBy>
  <cp:revision>5</cp:revision>
  <dcterms:created xsi:type="dcterms:W3CDTF">2026-01-16T19:03:52Z</dcterms:created>
  <dcterms:modified xsi:type="dcterms:W3CDTF">2026-01-24T10:20:10Z</dcterms:modified>
</cp:coreProperties>
</file>